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4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723" autoAdjust="0"/>
    <p:restoredTop sz="88632" autoAdjust="0"/>
  </p:normalViewPr>
  <p:slideViewPr>
    <p:cSldViewPr snapToGrid="0" snapToObjects="1">
      <p:cViewPr>
        <p:scale>
          <a:sx n="70" d="100"/>
          <a:sy n="70" d="100"/>
        </p:scale>
        <p:origin x="-2292" y="10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B3F9F-F21E-493F-BFEA-F1D2D09CFAD3}" type="datetimeFigureOut">
              <a:rPr lang="en-CA" smtClean="0"/>
              <a:pPr/>
              <a:t>22/05/2015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9345854-6294-413A-9C21-02DA63F77C4A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15077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9345854-6294-413A-9C21-02DA63F77C4A}" type="slidenum">
              <a:rPr lang="en-CA" smtClean="0"/>
              <a:pPr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422357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949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657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789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826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29210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43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54862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742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8614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57022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793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58C1F-3EE5-9F49-94D1-736A4CDE9B41}" type="datetimeFigureOut">
              <a:rPr lang="en-US" smtClean="0"/>
              <a:pPr/>
              <a:t>5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B7B2C2-12C5-DA42-94E7-562F0FE8637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30677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5" name="Group 104"/>
          <p:cNvGrpSpPr/>
          <p:nvPr/>
        </p:nvGrpSpPr>
        <p:grpSpPr>
          <a:xfrm>
            <a:off x="1664789" y="752178"/>
            <a:ext cx="2602049" cy="2195786"/>
            <a:chOff x="6479569" y="4081711"/>
            <a:chExt cx="2602049" cy="2195786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966611" y="4369819"/>
              <a:ext cx="687600" cy="687600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966611" y="5057419"/>
              <a:ext cx="687600" cy="68760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7654211" y="4369819"/>
              <a:ext cx="687600" cy="687600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654211" y="5057419"/>
              <a:ext cx="687600" cy="687600"/>
            </a:xfrm>
            <a:prstGeom prst="rect">
              <a:avLst/>
            </a:prstGeom>
          </p:spPr>
        </p:pic>
        <p:sp>
          <p:nvSpPr>
            <p:cNvPr id="26" name="TextBox 25"/>
            <p:cNvSpPr txBox="1"/>
            <p:nvPr/>
          </p:nvSpPr>
          <p:spPr>
            <a:xfrm>
              <a:off x="6699261" y="5730542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934489" y="5732802"/>
              <a:ext cx="505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7106639" y="5731541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7267776" y="5729161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7426359" y="5728935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6695650" y="5503110"/>
              <a:ext cx="505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699261" y="5338163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695082" y="5170414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6698613" y="5004506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35" name="Group 51"/>
            <p:cNvGrpSpPr/>
            <p:nvPr/>
          </p:nvGrpSpPr>
          <p:grpSpPr>
            <a:xfrm>
              <a:off x="6709397" y="5574076"/>
              <a:ext cx="457200" cy="457200"/>
              <a:chOff x="609590" y="2083234"/>
              <a:chExt cx="457200" cy="457200"/>
            </a:xfrm>
          </p:grpSpPr>
          <p:cxnSp>
            <p:nvCxnSpPr>
              <p:cNvPr id="57" name="Straight Arrow Connector 56"/>
              <p:cNvCxnSpPr/>
              <p:nvPr/>
            </p:nvCxnSpPr>
            <p:spPr>
              <a:xfrm>
                <a:off x="609590" y="2533650"/>
                <a:ext cx="457200" cy="158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Arrow Connector 57"/>
              <p:cNvCxnSpPr/>
              <p:nvPr/>
            </p:nvCxnSpPr>
            <p:spPr>
              <a:xfrm rot="5400000" flipH="1" flipV="1">
                <a:off x="389284" y="2311040"/>
                <a:ext cx="457200" cy="158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" name="TextBox 35"/>
            <p:cNvSpPr txBox="1"/>
            <p:nvPr/>
          </p:nvSpPr>
          <p:spPr>
            <a:xfrm>
              <a:off x="6635220" y="6031276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D69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6215373" y="5532114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D4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7039052" y="4081716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NP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7514063" y="4081711"/>
              <a:ext cx="10725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MOG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35-55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8307004" y="5237743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WT LHVS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8287839" y="4541379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WT 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7874039" y="5005971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3.34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222482" y="5007453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.85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7882062" y="4317203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62.1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187375" y="4322486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2.05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33" name="Group 132"/>
          <p:cNvGrpSpPr/>
          <p:nvPr/>
        </p:nvGrpSpPr>
        <p:grpSpPr>
          <a:xfrm>
            <a:off x="1640471" y="3337775"/>
            <a:ext cx="2602049" cy="2195786"/>
            <a:chOff x="6263834" y="3146096"/>
            <a:chExt cx="2602049" cy="2195786"/>
          </a:xfrm>
        </p:grpSpPr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731920" y="3459438"/>
              <a:ext cx="687600" cy="68760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419520" y="3459438"/>
              <a:ext cx="687600" cy="687600"/>
            </a:xfrm>
            <a:prstGeom prst="rect">
              <a:avLst/>
            </a:prstGeom>
          </p:spPr>
        </p:pic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6731920" y="4147038"/>
              <a:ext cx="687600" cy="687600"/>
            </a:xfrm>
            <a:prstGeom prst="rect">
              <a:avLst/>
            </a:prstGeom>
          </p:spPr>
        </p:pic>
        <p:pic>
          <p:nvPicPr>
            <p:cNvPr id="12" name="Picture 11"/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7419520" y="4147038"/>
              <a:ext cx="687600" cy="687600"/>
            </a:xfrm>
            <a:prstGeom prst="rect">
              <a:avLst/>
            </a:prstGeom>
          </p:spPr>
        </p:pic>
        <p:sp>
          <p:nvSpPr>
            <p:cNvPr id="111" name="TextBox 110"/>
            <p:cNvSpPr txBox="1"/>
            <p:nvPr/>
          </p:nvSpPr>
          <p:spPr>
            <a:xfrm>
              <a:off x="6483526" y="4794927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0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6718754" y="4797187"/>
              <a:ext cx="505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6890904" y="4795926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7052041" y="4793546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7210624" y="4793320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6479915" y="4567495"/>
              <a:ext cx="5059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1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6483526" y="4402548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479347" y="4234799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6482878" y="4068891"/>
              <a:ext cx="540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0</a:t>
              </a:r>
              <a:r>
                <a:rPr lang="en-US" sz="800" baseline="30000" dirty="0" smtClean="0">
                  <a:latin typeface="Arial" pitchFamily="34" charset="0"/>
                  <a:cs typeface="Arial" pitchFamily="34" charset="0"/>
                </a:rPr>
                <a:t>4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20" name="Group 51"/>
            <p:cNvGrpSpPr/>
            <p:nvPr/>
          </p:nvGrpSpPr>
          <p:grpSpPr>
            <a:xfrm>
              <a:off x="6493662" y="4638461"/>
              <a:ext cx="457200" cy="457200"/>
              <a:chOff x="609590" y="2083234"/>
              <a:chExt cx="457200" cy="457200"/>
            </a:xfrm>
          </p:grpSpPr>
          <p:cxnSp>
            <p:nvCxnSpPr>
              <p:cNvPr id="131" name="Straight Arrow Connector 130"/>
              <p:cNvCxnSpPr/>
              <p:nvPr/>
            </p:nvCxnSpPr>
            <p:spPr>
              <a:xfrm>
                <a:off x="609590" y="2533650"/>
                <a:ext cx="457200" cy="158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Straight Arrow Connector 131"/>
              <p:cNvCxnSpPr/>
              <p:nvPr/>
            </p:nvCxnSpPr>
            <p:spPr>
              <a:xfrm rot="5400000" flipH="1" flipV="1">
                <a:off x="389284" y="2311040"/>
                <a:ext cx="457200" cy="1588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21" name="TextBox 120"/>
            <p:cNvSpPr txBox="1"/>
            <p:nvPr/>
          </p:nvSpPr>
          <p:spPr>
            <a:xfrm>
              <a:off x="6419485" y="5095661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D69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 rot="16200000">
              <a:off x="5999638" y="4596499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D4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6823317" y="3146101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NP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7298328" y="3146096"/>
              <a:ext cx="107257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MOG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35-55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8091269" y="4302128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Cat B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-/-</a:t>
              </a:r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S</a:t>
              </a:r>
              <a:r>
                <a:rPr lang="en-US" sz="1000" baseline="30000" dirty="0" smtClean="0">
                  <a:latin typeface="Arial" pitchFamily="34" charset="0"/>
                  <a:cs typeface="Arial" pitchFamily="34" charset="0"/>
                </a:rPr>
                <a:t>-/-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8072104" y="3605764"/>
              <a:ext cx="7746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itchFamily="34" charset="0"/>
                  <a:cs typeface="Arial" pitchFamily="34" charset="0"/>
                </a:rPr>
                <a:t>WT </a:t>
              </a:r>
              <a:endParaRPr 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7658304" y="4108456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2.0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7006747" y="4100413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1.66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7666327" y="3410163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59.1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6971640" y="3415446"/>
              <a:ext cx="67587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smtClean="0">
                  <a:latin typeface="Arial" pitchFamily="34" charset="0"/>
                  <a:cs typeface="Arial" pitchFamily="34" charset="0"/>
                </a:rPr>
                <a:t>2.23%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9" name="TextBox 58"/>
          <p:cNvSpPr txBox="1"/>
          <p:nvPr/>
        </p:nvSpPr>
        <p:spPr>
          <a:xfrm>
            <a:off x="703046" y="5813788"/>
            <a:ext cx="508360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6 Fig.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Representative flow cytometry plots for Figures 3 and 4.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ctivation of MOG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specific 2D2 CD4+ T cells was determined by surface expression of CD69 after 16 h incubation with WT, LHVS-treated or cathepsin B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BMMØ that had been previously pulsed with 25 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/ml MOG</a:t>
            </a:r>
            <a:r>
              <a:rPr lang="en-US" sz="1000" baseline="30000" dirty="0">
                <a:latin typeface="Arial" panose="020B0604020202020204" pitchFamily="34" charset="0"/>
                <a:cs typeface="Arial" panose="020B0604020202020204" pitchFamily="34" charset="0"/>
              </a:rPr>
              <a:t>35-55</a:t>
            </a:r>
            <a:r>
              <a:rPr lang="en-CA" sz="1000" dirty="0">
                <a:latin typeface="Arial" panose="020B0604020202020204" pitchFamily="34" charset="0"/>
                <a:cs typeface="Arial" panose="020B0604020202020204" pitchFamily="34" charset="0"/>
              </a:rPr>
              <a:t> or no peptide (NP). </a:t>
            </a:r>
          </a:p>
        </p:txBody>
      </p:sp>
    </p:spTree>
    <p:extLst>
      <p:ext uri="{BB962C8B-B14F-4D97-AF65-F5344CB8AC3E}">
        <p14:creationId xmlns:p14="http://schemas.microsoft.com/office/powerpoint/2010/main" val="929745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93</TotalTime>
  <Words>111</Words>
  <Application>Microsoft Office PowerPoint</Application>
  <PresentationFormat>On-screen Show (4:3)</PresentationFormat>
  <Paragraphs>4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Euan</cp:lastModifiedBy>
  <cp:revision>1550</cp:revision>
  <dcterms:created xsi:type="dcterms:W3CDTF">2012-09-11T17:14:12Z</dcterms:created>
  <dcterms:modified xsi:type="dcterms:W3CDTF">2015-05-22T19:08:31Z</dcterms:modified>
</cp:coreProperties>
</file>